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73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2322" y="48"/>
      </p:cViewPr>
      <p:guideLst>
        <p:guide orient="horz" pos="312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an Serrels" userId="86e91761-c3e6-4845-ab00-7fc29f629832" providerId="ADAL" clId="{2445B801-D3BE-46EB-A1EE-1FAB9CF89A3C}"/>
    <pc:docChg chg="delSld">
      <pc:chgData name="Alan Serrels" userId="86e91761-c3e6-4845-ab00-7fc29f629832" providerId="ADAL" clId="{2445B801-D3BE-46EB-A1EE-1FAB9CF89A3C}" dt="2019-12-10T17:33:20.168" v="1" actId="47"/>
      <pc:docMkLst>
        <pc:docMk/>
      </pc:docMkLst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1523348991" sldId="256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2749029386" sldId="257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2040897816" sldId="265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416538339" sldId="266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857543609" sldId="267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816082619" sldId="269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1628143115" sldId="270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1613178199" sldId="271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2990871043" sldId="272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3091741688" sldId="275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1595445374" sldId="277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3799203409" sldId="280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1173233229" sldId="284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2293852697" sldId="286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2871491895" sldId="287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889567678" sldId="288"/>
        </pc:sldMkLst>
      </pc:sldChg>
      <pc:sldChg chg="del">
        <pc:chgData name="Alan Serrels" userId="86e91761-c3e6-4845-ab00-7fc29f629832" providerId="ADAL" clId="{2445B801-D3BE-46EB-A1EE-1FAB9CF89A3C}" dt="2019-12-10T17:33:18.532" v="0" actId="47"/>
        <pc:sldMkLst>
          <pc:docMk/>
          <pc:sldMk cId="650471643" sldId="289"/>
        </pc:sldMkLst>
      </pc:sldChg>
      <pc:sldChg chg="del">
        <pc:chgData name="Alan Serrels" userId="86e91761-c3e6-4845-ab00-7fc29f629832" providerId="ADAL" clId="{2445B801-D3BE-46EB-A1EE-1FAB9CF89A3C}" dt="2019-12-10T17:33:20.168" v="1" actId="47"/>
        <pc:sldMkLst>
          <pc:docMk/>
          <pc:sldMk cId="1613326722" sldId="29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278675-5809-364F-B601-D07E9C950081}" type="datetimeFigureOut">
              <a:rPr lang="en-GB" smtClean="0"/>
              <a:t>10/1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AD103-A63A-9440-A2FF-04AC717FAB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7782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51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435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2574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076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899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6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16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58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027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75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563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81F8E-2237-D242-8CDD-D54571C54928}" type="datetimeFigureOut">
              <a:rPr lang="en-US" smtClean="0"/>
              <a:t>12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1A9785-769F-334D-A16B-DAAD4C1917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236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C0ADE0D-25FE-428F-9DF2-2AF85474998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7659839"/>
              </p:ext>
            </p:extLst>
          </p:nvPr>
        </p:nvGraphicFramePr>
        <p:xfrm>
          <a:off x="1217436" y="286378"/>
          <a:ext cx="4423129" cy="365644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49411">
                  <a:extLst>
                    <a:ext uri="{9D8B030D-6E8A-4147-A177-3AD203B41FA5}">
                      <a16:colId xmlns:a16="http://schemas.microsoft.com/office/drawing/2014/main" val="500889471"/>
                    </a:ext>
                  </a:extLst>
                </a:gridCol>
                <a:gridCol w="823928">
                  <a:extLst>
                    <a:ext uri="{9D8B030D-6E8A-4147-A177-3AD203B41FA5}">
                      <a16:colId xmlns:a16="http://schemas.microsoft.com/office/drawing/2014/main" val="1119192057"/>
                    </a:ext>
                  </a:extLst>
                </a:gridCol>
                <a:gridCol w="1274895">
                  <a:extLst>
                    <a:ext uri="{9D8B030D-6E8A-4147-A177-3AD203B41FA5}">
                      <a16:colId xmlns:a16="http://schemas.microsoft.com/office/drawing/2014/main" val="1204841907"/>
                    </a:ext>
                  </a:extLst>
                </a:gridCol>
                <a:gridCol w="1274895">
                  <a:extLst>
                    <a:ext uri="{9D8B030D-6E8A-4147-A177-3AD203B41FA5}">
                      <a16:colId xmlns:a16="http://schemas.microsoft.com/office/drawing/2014/main" val="33744403"/>
                    </a:ext>
                  </a:extLst>
                </a:gridCol>
              </a:tblGrid>
              <a:tr h="304704"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g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o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oropho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b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li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9387398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il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ombie NI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070766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-F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F7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9706060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/7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5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586309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4/8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4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1788653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6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A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V3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2967248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4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-Dazz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2079619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6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1.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P-Cy5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7023664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0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A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6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0266332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L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F.9G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7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769773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L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9732010"/>
                  </a:ext>
                </a:extLst>
              </a:tr>
              <a:tr h="304704"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V6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legend</a:t>
                      </a:r>
                      <a:endParaRPr lang="en-GB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129261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8248980-05FC-4BF0-BB22-656E1C845C87}"/>
              </a:ext>
            </a:extLst>
          </p:cNvPr>
          <p:cNvSpPr txBox="1"/>
          <p:nvPr/>
        </p:nvSpPr>
        <p:spPr>
          <a:xfrm>
            <a:off x="0" y="4072242"/>
            <a:ext cx="68504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Arial" charset="0"/>
                <a:ea typeface="Arial" charset="0"/>
                <a:cs typeface="Arial" charset="0"/>
              </a:rPr>
              <a:t>Supplementary File 3.  </a:t>
            </a:r>
          </a:p>
        </p:txBody>
      </p:sp>
    </p:spTree>
    <p:extLst>
      <p:ext uri="{BB962C8B-B14F-4D97-AF65-F5344CB8AC3E}">
        <p14:creationId xmlns:p14="http://schemas.microsoft.com/office/powerpoint/2010/main" val="3686940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3F0A426BF62E459E3C05765B1FC3FA" ma:contentTypeVersion="11" ma:contentTypeDescription="Create a new document." ma:contentTypeScope="" ma:versionID="4f37cfc14288680114c50cc663027329">
  <xsd:schema xmlns:xsd="http://www.w3.org/2001/XMLSchema" xmlns:xs="http://www.w3.org/2001/XMLSchema" xmlns:p="http://schemas.microsoft.com/office/2006/metadata/properties" xmlns:ns3="7bef8c27-ce29-4f53-9f15-c6470b5a495d" xmlns:ns4="65005690-56e5-46b1-972d-4e9f8a663d03" targetNamespace="http://schemas.microsoft.com/office/2006/metadata/properties" ma:root="true" ma:fieldsID="8d36f809a07c15b056ffea9ec6738935" ns3:_="" ns4:_="">
    <xsd:import namespace="7bef8c27-ce29-4f53-9f15-c6470b5a495d"/>
    <xsd:import namespace="65005690-56e5-46b1-972d-4e9f8a663d03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DateTaken" minOccurs="0"/>
                <xsd:element ref="ns4:MediaServiceEventHashCode" minOccurs="0"/>
                <xsd:element ref="ns4:MediaServiceGenerationTime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bef8c27-ce29-4f53-9f15-c6470b5a495d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5005690-56e5-46b1-972d-4e9f8a663d0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MediaServiceAutoTags" ma:internalName="MediaServiceAutoTags" ma:readOnly="true">
      <xsd:simpleType>
        <xsd:restriction base="dms:Text"/>
      </xsd:simpleType>
    </xsd:element>
    <xsd:element name="MediaServiceOCR" ma:index="14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7FD7357-FCA2-4C26-B3AF-568A588673C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bef8c27-ce29-4f53-9f15-c6470b5a495d"/>
    <ds:schemaRef ds:uri="65005690-56e5-46b1-972d-4e9f8a663d0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7FB48D9-F8AD-421C-AC11-04105EB252B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3911D09-0FCB-4E01-A12E-184D92FE8E3C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</Words>
  <Application>Microsoft Office PowerPoint</Application>
  <PresentationFormat>A4 Paper (210x297 mm)</PresentationFormat>
  <Paragraphs>4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EL Marta</dc:creator>
  <cp:lastModifiedBy>Alan Serrels</cp:lastModifiedBy>
  <cp:revision>3</cp:revision>
  <cp:lastPrinted>2018-06-19T14:49:18Z</cp:lastPrinted>
  <dcterms:created xsi:type="dcterms:W3CDTF">2018-01-16T10:27:35Z</dcterms:created>
  <dcterms:modified xsi:type="dcterms:W3CDTF">2019-12-10T17:33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3F0A426BF62E459E3C05765B1FC3FA</vt:lpwstr>
  </property>
</Properties>
</file>